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374" autoAdjust="0"/>
  </p:normalViewPr>
  <p:slideViewPr>
    <p:cSldViewPr>
      <p:cViewPr>
        <p:scale>
          <a:sx n="200" d="100"/>
          <a:sy n="200" d="100"/>
        </p:scale>
        <p:origin x="372" y="-68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4" y="0"/>
            <a:ext cx="2971800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44E3FCA8-3BB1-492A-85F5-E25299772689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967"/>
            <a:ext cx="2971800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4" y="8829967"/>
            <a:ext cx="2971800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D42D78B3-0A5B-4E0A-8A7B-434F7B00C1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9258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A4D83B-AD05-46FD-89FB-5B88D4FC5BFA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6425"/>
            <a:ext cx="548640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29BD99-6AAD-434C-9052-2E76D33E5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3427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29BD99-6AAD-434C-9052-2E76D33E5D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5602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219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249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717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258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118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09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127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574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4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272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862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3E69C-AF89-49E7-B3EE-BBD1FCE94EA7}" type="datetimeFigureOut">
              <a:rPr lang="en-US" smtClean="0"/>
              <a:t>1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B99C4-D5EE-4931-B6F3-FE1BFC1DB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809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0041818"/>
              </p:ext>
            </p:extLst>
          </p:nvPr>
        </p:nvGraphicFramePr>
        <p:xfrm>
          <a:off x="304800" y="609600"/>
          <a:ext cx="6189391" cy="6893456"/>
        </p:xfrm>
        <a:graphic>
          <a:graphicData uri="http://schemas.openxmlformats.org/drawingml/2006/table">
            <a:tbl>
              <a:tblPr firstRow="1" firstCol="1" bandRow="1"/>
              <a:tblGrid>
                <a:gridCol w="12695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523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5231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763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0763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57200">
                <a:tc gridSpan="5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Supplementary Table 1. Parametric correlation coefficients of cytokine levels and mitochondrial responses in Monocytes and Lymphocytes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612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onocyte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Lymphocyte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6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aximal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serve Capacity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Maximal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serve Capacity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3430">
                <a:tc grid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10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S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301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FN-ɣ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0.713*</a:t>
                      </a:r>
                      <a:endParaRPr lang="en-US" sz="105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021)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0.704*</a:t>
                      </a:r>
                      <a:endParaRPr lang="en-US" sz="105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023)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0.583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130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0.541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167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1857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NF-ɑ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317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342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291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386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818*</a:t>
                      </a:r>
                      <a:endParaRPr lang="en-US" sz="105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024)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589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163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11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758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95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79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56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14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70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86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630541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6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86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64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861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148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726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47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3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547898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effectLst/>
                          <a:latin typeface="Arial" panose="020B0604020202020204" pitchFamily="34" charset="0"/>
                        </a:rPr>
                        <a:t>-0.723*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(p=0.04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effectLst/>
                          <a:latin typeface="Arial" panose="020B0604020202020204" pitchFamily="34" charset="0"/>
                        </a:rPr>
                        <a:t>-0.709*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(p=0.048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effectLst/>
                          <a:latin typeface="Arial" panose="020B0604020202020204" pitchFamily="34" charset="0"/>
                        </a:rPr>
                        <a:t>-0.787*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(p=0.02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474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3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3402706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GFb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effectLst/>
                          <a:latin typeface="Arial" panose="020B0604020202020204" pitchFamily="34" charset="0"/>
                        </a:rPr>
                        <a:t>0.749*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(p=0.04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497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56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320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601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281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64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67061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VEGF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37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475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14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12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42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493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19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1387973"/>
                  </a:ext>
                </a:extLst>
              </a:tr>
              <a:tr h="341412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C/PBS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0957630"/>
                  </a:ext>
                </a:extLst>
              </a:tr>
              <a:tr h="41645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FN-ɣ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104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748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102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751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0.046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844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050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(p=0.885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6547444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NF-ɑ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547*</a:t>
                      </a:r>
                      <a:endParaRPr lang="en-US" sz="105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043)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550*</a:t>
                      </a:r>
                      <a:endParaRPr lang="en-US" sz="105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b="1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041)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242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474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5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202</a:t>
                      </a:r>
                      <a:endParaRPr lang="en-US" sz="105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200"/>
                        </a:spcAft>
                      </a:pPr>
                      <a:r>
                        <a:rPr lang="en-US" sz="1000" kern="12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p=0.552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126052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100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75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07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82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148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66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60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86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8224294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285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36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379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2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323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332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285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396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154838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440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7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effectLst/>
                          <a:latin typeface="Arial" panose="020B0604020202020204" pitchFamily="34" charset="0"/>
                        </a:rPr>
                        <a:t>-0.700*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(p=0.05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43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89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270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421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34122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TGFb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536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7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601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0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642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4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365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546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678291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VEGF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50750" marR="507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257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8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257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8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-0.097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42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effectLst/>
                          <a:latin typeface="Arial" panose="020B0604020202020204" pitchFamily="34" charset="0"/>
                        </a:rPr>
                        <a:t>0.318</a:t>
                      </a:r>
                    </a:p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(p=0.26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686636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250437" y="7620000"/>
            <a:ext cx="6243753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—HS=Healthy Subjects; IC/PBS=Interstitial cystitis/painful bladder syndrome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—IFN-ɣ=Interferon gamma; TNF-ɑ, Tumor Necrosis Factor alpha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—An asterisk indicates a statistically significant result (p&lt;0.05).</a:t>
            </a:r>
          </a:p>
        </p:txBody>
      </p:sp>
    </p:spTree>
    <p:extLst>
      <p:ext uri="{BB962C8B-B14F-4D97-AF65-F5344CB8AC3E}">
        <p14:creationId xmlns:p14="http://schemas.microsoft.com/office/powerpoint/2010/main" val="450598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68</TotalTime>
  <Words>468</Words>
  <Application>Microsoft Office PowerPoint</Application>
  <PresentationFormat>On-screen Show (4:3)</PresentationFormat>
  <Paragraphs>1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ecia Mitchell</dc:creator>
  <cp:lastModifiedBy>Mitchell, Tanecia (Campus)</cp:lastModifiedBy>
  <cp:revision>206</cp:revision>
  <cp:lastPrinted>2017-08-24T13:43:44Z</cp:lastPrinted>
  <dcterms:created xsi:type="dcterms:W3CDTF">2016-04-25T21:05:04Z</dcterms:created>
  <dcterms:modified xsi:type="dcterms:W3CDTF">2024-01-11T00:22:26Z</dcterms:modified>
</cp:coreProperties>
</file>